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embeddedFontLst>
    <p:embeddedFont>
      <p:font typeface="Calibri Light" panose="020F0302020204030204" pitchFamily="34" charset="0"/>
      <p:regular r:id="rId3"/>
      <p:italic r:id="rId4"/>
    </p:embeddedFont>
    <p:embeddedFont>
      <p:font typeface="Calibri" panose="020F0502020204030204" pitchFamily="34" charset="0"/>
      <p:regular r:id="rId5"/>
      <p:bold r:id="rId6"/>
      <p:italic r:id="rId7"/>
      <p:boldItalic r:id="rId8"/>
    </p:embeddedFont>
  </p:embeddedFontLst>
  <p:custDataLst>
    <p:tags r:id="rId9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47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6.fntdata"/><Relationship Id="rId13" Type="http://schemas.openxmlformats.org/officeDocument/2006/relationships/tableStyles" Target="tableStyles.xml"/><Relationship Id="rId3" Type="http://schemas.openxmlformats.org/officeDocument/2006/relationships/font" Target="fonts/font1.fntdata"/><Relationship Id="rId7" Type="http://schemas.openxmlformats.org/officeDocument/2006/relationships/font" Target="fonts/font5.fntdata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11" Type="http://schemas.openxmlformats.org/officeDocument/2006/relationships/viewProps" Target="viewProps.xml"/><Relationship Id="rId5" Type="http://schemas.openxmlformats.org/officeDocument/2006/relationships/font" Target="fonts/font3.fntdata"/><Relationship Id="rId10" Type="http://schemas.openxmlformats.org/officeDocument/2006/relationships/presProps" Target="presProps.xml"/><Relationship Id="rId4" Type="http://schemas.openxmlformats.org/officeDocument/2006/relationships/font" Target="fonts/font2.fntdata"/><Relationship Id="rId9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2D1B4-ED9B-49FC-A0E9-28BB5A372F83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6754-CFA6-4E10-AC61-7E864724639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58782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2D1B4-ED9B-49FC-A0E9-28BB5A372F83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6754-CFA6-4E10-AC61-7E864724639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762275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2D1B4-ED9B-49FC-A0E9-28BB5A372F83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6754-CFA6-4E10-AC61-7E864724639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8061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2D1B4-ED9B-49FC-A0E9-28BB5A372F83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6754-CFA6-4E10-AC61-7E864724639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13324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2D1B4-ED9B-49FC-A0E9-28BB5A372F83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6754-CFA6-4E10-AC61-7E864724639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76024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2D1B4-ED9B-49FC-A0E9-28BB5A372F83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6754-CFA6-4E10-AC61-7E864724639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54340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2D1B4-ED9B-49FC-A0E9-28BB5A372F83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6754-CFA6-4E10-AC61-7E864724639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34279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2D1B4-ED9B-49FC-A0E9-28BB5A372F83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6754-CFA6-4E10-AC61-7E864724639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90426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2D1B4-ED9B-49FC-A0E9-28BB5A372F83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6754-CFA6-4E10-AC61-7E864724639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678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2D1B4-ED9B-49FC-A0E9-28BB5A372F83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6754-CFA6-4E10-AC61-7E864724639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18169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2D1B4-ED9B-49FC-A0E9-28BB5A372F83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6754-CFA6-4E10-AC61-7E864724639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06981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42D1B4-ED9B-49FC-A0E9-28BB5A372F83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B56754-CFA6-4E10-AC61-7E864724639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38042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6266" y="2465151"/>
            <a:ext cx="1647740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" name="Straight Connector 4"/>
          <p:cNvCxnSpPr/>
          <p:nvPr/>
        </p:nvCxnSpPr>
        <p:spPr bwMode="auto">
          <a:xfrm>
            <a:off x="3790179" y="2334346"/>
            <a:ext cx="3873827" cy="0"/>
          </a:xfrm>
          <a:prstGeom prst="line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9979" y="246614"/>
            <a:ext cx="1686576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1191" y="246614"/>
            <a:ext cx="1647740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71816" y="246614"/>
            <a:ext cx="1686576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1191" y="2465151"/>
            <a:ext cx="1647740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2463918" y="1805652"/>
            <a:ext cx="6174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1419735" y="925809"/>
            <a:ext cx="6174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120102" y="1805652"/>
            <a:ext cx="14302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ombie :: </a:t>
            </a:r>
            <a:r>
              <a:rPr lang="en-US" sz="1100" b="1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Cyan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3553020" y="925810"/>
            <a:ext cx="5934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685404" y="1805652"/>
            <a:ext cx="6174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5620767" y="925809"/>
            <a:ext cx="6254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Arrow Connector 15"/>
          <p:cNvCxnSpPr/>
          <p:nvPr/>
        </p:nvCxnSpPr>
        <p:spPr bwMode="auto">
          <a:xfrm>
            <a:off x="3325357" y="698859"/>
            <a:ext cx="638589" cy="0"/>
          </a:xfrm>
          <a:prstGeom prst="straightConnector1">
            <a:avLst/>
          </a:prstGeom>
          <a:noFill/>
          <a:ln w="2540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lg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7" name="Straight Arrow Connector 16"/>
          <p:cNvCxnSpPr/>
          <p:nvPr/>
        </p:nvCxnSpPr>
        <p:spPr bwMode="auto">
          <a:xfrm>
            <a:off x="4525053" y="692401"/>
            <a:ext cx="1494856" cy="0"/>
          </a:xfrm>
          <a:prstGeom prst="straightConnector1">
            <a:avLst/>
          </a:prstGeom>
          <a:noFill/>
          <a:ln w="2540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lg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8" name="TextBox 17"/>
          <p:cNvSpPr txBox="1"/>
          <p:nvPr/>
        </p:nvSpPr>
        <p:spPr>
          <a:xfrm>
            <a:off x="6178220" y="1381584"/>
            <a:ext cx="354584" cy="261610"/>
          </a:xfrm>
          <a:prstGeom prst="rect">
            <a:avLst/>
          </a:prstGeom>
          <a:gradFill flip="none" rotWithShape="1">
            <a:gsLst>
              <a:gs pos="19000">
                <a:srgbClr val="FFFFFF"/>
              </a:gs>
              <a:gs pos="65000">
                <a:srgbClr val="FFFFFF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none" rtlCol="0">
            <a:spAutoFit/>
          </a:bodyPr>
          <a:lstStyle/>
          <a:p>
            <a:pPr marL="0" marR="0" lvl="0" indent="0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1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568175" y="1232667"/>
            <a:ext cx="354584" cy="261610"/>
          </a:xfrm>
          <a:prstGeom prst="rect">
            <a:avLst/>
          </a:prstGeom>
          <a:gradFill flip="none" rotWithShape="1">
            <a:gsLst>
              <a:gs pos="19000">
                <a:srgbClr val="FFFFFF"/>
              </a:gs>
              <a:gs pos="65000">
                <a:srgbClr val="FFFFFF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none" rtlCol="0">
            <a:spAutoFit/>
          </a:bodyPr>
          <a:lstStyle/>
          <a:p>
            <a:pPr marL="0" marR="0" lvl="0" indent="0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2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7200648" y="1438407"/>
            <a:ext cx="354584" cy="261610"/>
          </a:xfrm>
          <a:prstGeom prst="rect">
            <a:avLst/>
          </a:prstGeom>
          <a:gradFill flip="none" rotWithShape="1">
            <a:gsLst>
              <a:gs pos="19000">
                <a:srgbClr val="FFFFFF"/>
              </a:gs>
              <a:gs pos="65000">
                <a:srgbClr val="FFFFFF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none" rtlCol="0">
            <a:spAutoFit/>
          </a:bodyPr>
          <a:lstStyle/>
          <a:p>
            <a:pPr marL="0" marR="0" lvl="0" indent="0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343339" y="767398"/>
            <a:ext cx="354584" cy="261610"/>
          </a:xfrm>
          <a:prstGeom prst="rect">
            <a:avLst/>
          </a:prstGeom>
          <a:gradFill flip="none" rotWithShape="1">
            <a:gsLst>
              <a:gs pos="19000">
                <a:srgbClr val="FFFFFF"/>
              </a:gs>
              <a:gs pos="65000">
                <a:srgbClr val="FFFFFF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none" rtlCol="0">
            <a:spAutoFit/>
          </a:bodyPr>
          <a:lstStyle/>
          <a:p>
            <a:pPr marL="0" marR="0" lvl="0" indent="0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4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354358" y="342442"/>
            <a:ext cx="354584" cy="261610"/>
          </a:xfrm>
          <a:prstGeom prst="rect">
            <a:avLst/>
          </a:prstGeom>
          <a:gradFill flip="none" rotWithShape="1">
            <a:gsLst>
              <a:gs pos="19000">
                <a:srgbClr val="FFFFFF"/>
              </a:gs>
              <a:gs pos="65000">
                <a:srgbClr val="FFFFFF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none" rtlCol="0">
            <a:spAutoFit/>
          </a:bodyPr>
          <a:lstStyle/>
          <a:p>
            <a:pPr marL="0" marR="0" lvl="0" indent="0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5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213675" y="4039344"/>
            <a:ext cx="12522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e :: BUV395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3110591" y="3144347"/>
            <a:ext cx="14782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1 :: DyLight488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404066" y="4039344"/>
            <a:ext cx="1095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35 :: APC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5414781" y="3144346"/>
            <a:ext cx="10374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a-BV786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966069" y="2203541"/>
            <a:ext cx="1414170" cy="261610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2 – Lymphocytes</a:t>
            </a:r>
          </a:p>
        </p:txBody>
      </p:sp>
      <p:pic>
        <p:nvPicPr>
          <p:cNvPr id="28" name="Picture 1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1729" y="2465151"/>
            <a:ext cx="1647740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TextBox 28"/>
          <p:cNvSpPr txBox="1"/>
          <p:nvPr/>
        </p:nvSpPr>
        <p:spPr>
          <a:xfrm>
            <a:off x="2204742" y="4039344"/>
            <a:ext cx="10166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5 :: APC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1212948" y="3144346"/>
            <a:ext cx="10310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61 :: FITC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Picture 1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1729" y="4841415"/>
            <a:ext cx="1647740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" name="Picture 14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1191" y="4841415"/>
            <a:ext cx="1647740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" name="Picture 15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6266" y="4841415"/>
            <a:ext cx="1647740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4" name="TextBox 33"/>
          <p:cNvSpPr txBox="1"/>
          <p:nvPr/>
        </p:nvSpPr>
        <p:spPr>
          <a:xfrm>
            <a:off x="1855336" y="6432493"/>
            <a:ext cx="17219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72a :: PerCP-Cy5.5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16200000">
            <a:off x="1157644" y="5520610"/>
            <a:ext cx="11416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 :: AF700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963162" y="6425591"/>
            <a:ext cx="17219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72a :: PerCP-Cy5.5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3334211" y="5520610"/>
            <a:ext cx="10310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52 :: FITC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075807" y="6433304"/>
            <a:ext cx="17219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72a :: PerCP-Cy5.5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16200000">
            <a:off x="5417987" y="5520610"/>
            <a:ext cx="10310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52 :: FITC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/>
          <p:cNvCxnSpPr/>
          <p:nvPr/>
        </p:nvCxnSpPr>
        <p:spPr bwMode="auto">
          <a:xfrm>
            <a:off x="1677826" y="2334346"/>
            <a:ext cx="1746191" cy="0"/>
          </a:xfrm>
          <a:prstGeom prst="line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41" name="TextBox 40"/>
          <p:cNvSpPr txBox="1"/>
          <p:nvPr/>
        </p:nvSpPr>
        <p:spPr>
          <a:xfrm>
            <a:off x="1991313" y="2203541"/>
            <a:ext cx="1119217" cy="261610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1 – Platelets</a:t>
            </a:r>
          </a:p>
        </p:txBody>
      </p:sp>
      <p:cxnSp>
        <p:nvCxnSpPr>
          <p:cNvPr id="42" name="Straight Connector 41"/>
          <p:cNvCxnSpPr/>
          <p:nvPr/>
        </p:nvCxnSpPr>
        <p:spPr bwMode="auto">
          <a:xfrm>
            <a:off x="1677826" y="4710610"/>
            <a:ext cx="1746191" cy="0"/>
          </a:xfrm>
          <a:prstGeom prst="line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43" name="TextBox 42"/>
          <p:cNvSpPr txBox="1"/>
          <p:nvPr/>
        </p:nvSpPr>
        <p:spPr>
          <a:xfrm>
            <a:off x="1931200" y="4579805"/>
            <a:ext cx="1239442" cy="261610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3 – Monocytes</a:t>
            </a:r>
          </a:p>
        </p:txBody>
      </p:sp>
      <p:cxnSp>
        <p:nvCxnSpPr>
          <p:cNvPr id="44" name="Straight Connector 43"/>
          <p:cNvCxnSpPr/>
          <p:nvPr/>
        </p:nvCxnSpPr>
        <p:spPr bwMode="auto">
          <a:xfrm>
            <a:off x="3790179" y="4710610"/>
            <a:ext cx="1746191" cy="0"/>
          </a:xfrm>
          <a:prstGeom prst="line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45" name="TextBox 44"/>
          <p:cNvSpPr txBox="1"/>
          <p:nvPr/>
        </p:nvSpPr>
        <p:spPr>
          <a:xfrm>
            <a:off x="4014700" y="4579805"/>
            <a:ext cx="1297151" cy="261610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4 – Neutrophils</a:t>
            </a:r>
          </a:p>
        </p:txBody>
      </p:sp>
      <p:cxnSp>
        <p:nvCxnSpPr>
          <p:cNvPr id="46" name="Straight Connector 45"/>
          <p:cNvCxnSpPr/>
          <p:nvPr/>
        </p:nvCxnSpPr>
        <p:spPr bwMode="auto">
          <a:xfrm>
            <a:off x="5885718" y="4710610"/>
            <a:ext cx="1746191" cy="0"/>
          </a:xfrm>
          <a:prstGeom prst="line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47" name="TextBox 46"/>
          <p:cNvSpPr txBox="1"/>
          <p:nvPr/>
        </p:nvSpPr>
        <p:spPr>
          <a:xfrm>
            <a:off x="6102225" y="4579805"/>
            <a:ext cx="1313180" cy="261610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5 – Eosinophils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4107155" y="2712940"/>
            <a:ext cx="524503" cy="400110"/>
          </a:xfrm>
          <a:prstGeom prst="rect">
            <a:avLst/>
          </a:prstGeom>
          <a:gradFill flip="none" rotWithShape="1">
            <a:gsLst>
              <a:gs pos="19000">
                <a:srgbClr val="FFFFFF"/>
              </a:gs>
              <a:gs pos="65000">
                <a:srgbClr val="FFFFFF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none" rtlCol="0"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.9%</a:t>
            </a:r>
            <a:b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6827312" y="2890556"/>
            <a:ext cx="607859" cy="400110"/>
          </a:xfrm>
          <a:prstGeom prst="rect">
            <a:avLst/>
          </a:prstGeom>
          <a:gradFill flip="none" rotWithShape="1">
            <a:gsLst>
              <a:gs pos="19000">
                <a:srgbClr val="FFFFFF"/>
              </a:gs>
              <a:gs pos="65000">
                <a:srgbClr val="FFFFFF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none" rtlCol="0"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.5%</a:t>
            </a:r>
            <a:b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NK cells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930500" y="2567223"/>
            <a:ext cx="627095" cy="400110"/>
          </a:xfrm>
          <a:prstGeom prst="rect">
            <a:avLst/>
          </a:prstGeom>
          <a:gradFill flip="none" rotWithShape="1">
            <a:gsLst>
              <a:gs pos="19000">
                <a:srgbClr val="FFFFFF"/>
              </a:gs>
              <a:gs pos="65000">
                <a:srgbClr val="FFFFFF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none" rtlCol="0"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79%</a:t>
            </a:r>
            <a:b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latelets</a:t>
            </a:r>
            <a:endParaRPr kumimoji="0" lang="en-US" sz="1100" b="0" i="0" u="none" strike="noStrike" kern="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5116487" y="3556862"/>
            <a:ext cx="518091" cy="400110"/>
          </a:xfrm>
          <a:prstGeom prst="rect">
            <a:avLst/>
          </a:prstGeom>
          <a:gradFill flip="none" rotWithShape="1">
            <a:gsLst>
              <a:gs pos="19000">
                <a:srgbClr val="FFFFFF"/>
              </a:gs>
              <a:gs pos="65000">
                <a:srgbClr val="FFFFFF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none" rtlCol="0"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84%</a:t>
            </a:r>
            <a:b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 cells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204166" y="4948111"/>
            <a:ext cx="742511" cy="400110"/>
          </a:xfrm>
          <a:prstGeom prst="rect">
            <a:avLst/>
          </a:prstGeom>
          <a:gradFill flip="none" rotWithShape="1">
            <a:gsLst>
              <a:gs pos="19000">
                <a:srgbClr val="FFFFFF"/>
              </a:gs>
              <a:gs pos="65000">
                <a:srgbClr val="FFFFFF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none" rtlCol="0"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90%</a:t>
            </a:r>
            <a:b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4279194" y="5066764"/>
            <a:ext cx="768160" cy="400110"/>
          </a:xfrm>
          <a:prstGeom prst="rect">
            <a:avLst/>
          </a:prstGeom>
          <a:gradFill flip="none" rotWithShape="1">
            <a:gsLst>
              <a:gs pos="19000">
                <a:srgbClr val="FFFFFF"/>
              </a:gs>
              <a:gs pos="65000">
                <a:srgbClr val="FFFFFF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none" rtlCol="0"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98%</a:t>
            </a:r>
            <a:b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Neutrophils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6246403" y="5492486"/>
            <a:ext cx="774572" cy="400110"/>
          </a:xfrm>
          <a:prstGeom prst="rect">
            <a:avLst/>
          </a:prstGeom>
          <a:gradFill flip="none" rotWithShape="1">
            <a:gsLst>
              <a:gs pos="19000">
                <a:srgbClr val="FFFFFF"/>
              </a:gs>
              <a:gs pos="65000">
                <a:srgbClr val="FFFFFF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none" rtlCol="0"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94%</a:t>
            </a:r>
            <a:br>
              <a:rPr kumimoji="0" lang="en-US" sz="110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0" lang="en-US" sz="9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Eosinophils</a:t>
            </a:r>
          </a:p>
        </p:txBody>
      </p:sp>
      <p:cxnSp>
        <p:nvCxnSpPr>
          <p:cNvPr id="55" name="Straight Arrow Connector 54"/>
          <p:cNvCxnSpPr/>
          <p:nvPr/>
        </p:nvCxnSpPr>
        <p:spPr bwMode="auto">
          <a:xfrm>
            <a:off x="4681351" y="3367352"/>
            <a:ext cx="1065515" cy="0"/>
          </a:xfrm>
          <a:prstGeom prst="straightConnector1">
            <a:avLst/>
          </a:prstGeom>
          <a:noFill/>
          <a:ln w="2540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lg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56" name="Straight Arrow Connector 55"/>
          <p:cNvCxnSpPr/>
          <p:nvPr/>
        </p:nvCxnSpPr>
        <p:spPr bwMode="auto">
          <a:xfrm flipH="1">
            <a:off x="4393351" y="3367351"/>
            <a:ext cx="288000" cy="288032"/>
          </a:xfrm>
          <a:prstGeom prst="straightConnector1">
            <a:avLst/>
          </a:prstGeom>
          <a:noFill/>
          <a:ln w="254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</p:spTree>
    <p:extLst>
      <p:ext uri="{BB962C8B-B14F-4D97-AF65-F5344CB8AC3E}">
        <p14:creationId xmlns:p14="http://schemas.microsoft.com/office/powerpoint/2010/main" val="117080213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SLIDEFORMAT" val="RXP"/>
  <p:tag name="VARPPTCOMPATIBLE4" val="RXP"/>
  <p:tag name="VARSAVEMESSAGETIMESTAMP" val="RXP31.10.2018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6</Words>
  <Application>Microsoft Office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 Light</vt:lpstr>
      <vt:lpstr>Calibri</vt:lpstr>
      <vt:lpstr>Office Theme</vt:lpstr>
      <vt:lpstr>PowerPoint Presentation</vt:lpstr>
    </vt:vector>
  </TitlesOfParts>
  <Company>F. Hoffmann-La Roche, Ltd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gli, Jerome {PNFD~Basel}</dc:creator>
  <cp:lastModifiedBy>Egli, Jerome {PNFD~Basel}</cp:lastModifiedBy>
  <cp:revision>2</cp:revision>
  <dcterms:created xsi:type="dcterms:W3CDTF">2018-10-31T11:52:27Z</dcterms:created>
  <dcterms:modified xsi:type="dcterms:W3CDTF">2018-10-31T11:54:54Z</dcterms:modified>
</cp:coreProperties>
</file>